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90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398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AE43-63F0-4DF3-9FC1-FFE36CC3E95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7BE9A-1E25-4087-ACFC-03E2B7A81E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1698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AE43-63F0-4DF3-9FC1-FFE36CC3E95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7BE9A-1E25-4087-ACFC-03E2B7A81E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9756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AE43-63F0-4DF3-9FC1-FFE36CC3E95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7BE9A-1E25-4087-ACFC-03E2B7A81E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9677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AE43-63F0-4DF3-9FC1-FFE36CC3E95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7BE9A-1E25-4087-ACFC-03E2B7A81E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34273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AE43-63F0-4DF3-9FC1-FFE36CC3E95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7BE9A-1E25-4087-ACFC-03E2B7A81E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80280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AE43-63F0-4DF3-9FC1-FFE36CC3E95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7BE9A-1E25-4087-ACFC-03E2B7A81E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9558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AE43-63F0-4DF3-9FC1-FFE36CC3E95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7BE9A-1E25-4087-ACFC-03E2B7A81E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8182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AE43-63F0-4DF3-9FC1-FFE36CC3E95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7BE9A-1E25-4087-ACFC-03E2B7A81E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7976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AE43-63F0-4DF3-9FC1-FFE36CC3E95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7BE9A-1E25-4087-ACFC-03E2B7A81E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5779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AE43-63F0-4DF3-9FC1-FFE36CC3E95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7BE9A-1E25-4087-ACFC-03E2B7A81E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9010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AE43-63F0-4DF3-9FC1-FFE36CC3E95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27BE9A-1E25-4087-ACFC-03E2B7A81E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0789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CBAE43-63F0-4DF3-9FC1-FFE36CC3E95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27BE9A-1E25-4087-ACFC-03E2B7A81E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7106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0563" y="1019175"/>
            <a:ext cx="5334000" cy="30099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그림 4" descr="텍스트, 라인, 그래프, 도표이(가) 표시된 사진&#10;&#10;자동 생성된 설명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0563" y="4410075"/>
            <a:ext cx="5334000" cy="3076575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6"/>
          <p:cNvSpPr txBox="1"/>
          <p:nvPr/>
        </p:nvSpPr>
        <p:spPr>
          <a:xfrm>
            <a:off x="347774" y="780543"/>
            <a:ext cx="491738" cy="365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1">
              <a:lnSpc>
                <a:spcPct val="107000"/>
              </a:lnSpc>
              <a:spcAft>
                <a:spcPts val="800"/>
              </a:spcAft>
            </a:pPr>
            <a:r>
              <a:rPr lang="en-US" sz="1500" b="1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 </a:t>
            </a:r>
            <a:endParaRPr lang="ko-KR" sz="1500" b="1" kern="100" dirty="0">
              <a:effectLst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08734" y="4120107"/>
            <a:ext cx="491738" cy="365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1">
              <a:lnSpc>
                <a:spcPct val="107000"/>
              </a:lnSpc>
              <a:spcAft>
                <a:spcPts val="800"/>
              </a:spcAft>
            </a:pPr>
            <a:r>
              <a:rPr lang="en-US" sz="1500" b="1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 </a:t>
            </a:r>
            <a:endParaRPr lang="ko-KR" sz="1500" b="1" kern="100" dirty="0">
              <a:effectLst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116254" y="7867650"/>
            <a:ext cx="669094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altLang="ko-KR" sz="12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</a:t>
            </a:r>
            <a:r>
              <a:rPr lang="en-US" altLang="ko-KR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2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US" altLang="ko-KR" sz="12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GC-MS total ion chromatograms (TICs) obtained from the analysis of culture filtrate of BCA19. (A and B)</a:t>
            </a:r>
            <a:r>
              <a:rPr lang="en-US" altLang="ko-KR" sz="12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 TICs obtained from the analysis of ethyl acetate </a:t>
            </a:r>
            <a:r>
              <a:rPr lang="en-US" altLang="ko-KR" sz="12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ko-KR" sz="12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 and n-butanol </a:t>
            </a:r>
            <a:r>
              <a:rPr lang="en-US" altLang="ko-KR" sz="12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ko-KR" sz="12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 extracts</a:t>
            </a:r>
            <a:r>
              <a:rPr lang="en-US" altLang="ko-KR" sz="1200" kern="100" dirty="0">
                <a:latin typeface="Arial" panose="020B0604020202020204" pitchFamily="34" charset="0"/>
                <a:cs typeface="Arial" panose="020B0604020202020204" pitchFamily="34" charset="0"/>
              </a:rPr>
              <a:t>. Peaks indicated the presence of different substances</a:t>
            </a:r>
            <a:r>
              <a:rPr lang="en-US" altLang="ko-KR" sz="12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altLang="ko-KR" sz="12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7550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5</Words>
  <Application>Microsoft Office PowerPoint</Application>
  <PresentationFormat>화면 슬라이드 쇼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</cp:revision>
  <dcterms:created xsi:type="dcterms:W3CDTF">2024-10-20T09:32:30Z</dcterms:created>
  <dcterms:modified xsi:type="dcterms:W3CDTF">2024-10-20T09:33:06Z</dcterms:modified>
</cp:coreProperties>
</file>